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241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899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82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346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060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28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717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528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366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554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697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812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EB80BE-42F8-4526-893D-E6679FC90BAC}" type="datetimeFigureOut">
              <a:rPr lang="en-US" smtClean="0"/>
              <a:t>9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879B40-5CD0-4CF8-AAFE-F8F3969595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502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5CB3CC74-E415-48B7-B468-BF59E2984E48}"/>
              </a:ext>
            </a:extLst>
          </p:cNvPr>
          <p:cNvSpPr txBox="1"/>
          <p:nvPr/>
        </p:nvSpPr>
        <p:spPr>
          <a:xfrm>
            <a:off x="171992" y="189033"/>
            <a:ext cx="1335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. Fig. 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A22A9D1F-DABB-4082-A7C6-5A5F2C2DE871}"/>
              </a:ext>
            </a:extLst>
          </p:cNvPr>
          <p:cNvSpPr/>
          <p:nvPr/>
        </p:nvSpPr>
        <p:spPr>
          <a:xfrm>
            <a:off x="344900" y="4778415"/>
            <a:ext cx="6003008" cy="13356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/>
              <a:t>Suppl. Fig. 1: </a:t>
            </a:r>
            <a:r>
              <a:rPr lang="en-US" sz="1100" dirty="0"/>
              <a:t>Differential abundance (</a:t>
            </a:r>
            <a:r>
              <a:rPr lang="en-US" sz="1100" dirty="0" err="1"/>
              <a:t>LEfSe</a:t>
            </a:r>
            <a:r>
              <a:rPr lang="en-US" sz="1100" dirty="0"/>
              <a:t> analysis) plot of significant OTU at species level between CHOW+GWI (GWI persistence in lean mice) and WD+GWI (GWI persistence in obese mice) groups. The </a:t>
            </a:r>
            <a:r>
              <a:rPr lang="en-US" sz="1100" dirty="0" err="1"/>
              <a:t>LEfSe</a:t>
            </a:r>
            <a:r>
              <a:rPr lang="en-US" sz="1100" dirty="0"/>
              <a:t> analysis is calculated using three methods: Kruskal-Wallis sum-rank test, Wilcoxon rank-sum test, and Linear Discriminant Analysis. Analysis meet p≤0.05 for Kruskal-Wallis and Wilcoxon tests and have an LDA score ≥ 2.0 or ≤ -2.0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xmlns="" id="{568F90DC-F811-44A7-9252-DC450A07800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031" t="7761" r="6566"/>
          <a:stretch/>
        </p:blipFill>
        <p:spPr>
          <a:xfrm>
            <a:off x="103090" y="747605"/>
            <a:ext cx="6651819" cy="3599877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107247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18</TotalTime>
  <Words>88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urabh Chatterjee</dc:creator>
  <cp:lastModifiedBy>MDPI</cp:lastModifiedBy>
  <cp:revision>12</cp:revision>
  <dcterms:created xsi:type="dcterms:W3CDTF">2020-07-02T13:13:27Z</dcterms:created>
  <dcterms:modified xsi:type="dcterms:W3CDTF">2020-09-09T03:18:35Z</dcterms:modified>
</cp:coreProperties>
</file>